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906000" cy="6858000" type="A4"/>
  <p:notesSz cx="9144000" cy="6858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9419"/>
    <a:srgbClr val="FFB030"/>
    <a:srgbClr val="D64291"/>
    <a:srgbClr val="B045AD"/>
    <a:srgbClr val="BB4BB9"/>
    <a:srgbClr val="2647D2"/>
    <a:srgbClr val="38A761"/>
    <a:srgbClr val="003F1C"/>
    <a:srgbClr val="A7EE5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150"/>
    <p:restoredTop sz="94674"/>
  </p:normalViewPr>
  <p:slideViewPr>
    <p:cSldViewPr snapToGrid="0" snapToObjects="1">
      <p:cViewPr varScale="1">
        <p:scale>
          <a:sx n="131" d="100"/>
          <a:sy n="131" d="100"/>
        </p:scale>
        <p:origin x="1144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C2ACE-12A3-5944-BFEF-67A4AB473A1B}" type="datetimeFigureOut">
              <a:rPr lang="it-IT" smtClean="0"/>
              <a:t>28/05/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4B168-B862-6944-BF16-539E26AF596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511254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C2ACE-12A3-5944-BFEF-67A4AB473A1B}" type="datetimeFigureOut">
              <a:rPr lang="it-IT" smtClean="0"/>
              <a:t>28/05/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4B168-B862-6944-BF16-539E26AF596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693952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C2ACE-12A3-5944-BFEF-67A4AB473A1B}" type="datetimeFigureOut">
              <a:rPr lang="it-IT" smtClean="0"/>
              <a:t>28/05/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4B168-B862-6944-BF16-539E26AF596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8016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C2ACE-12A3-5944-BFEF-67A4AB473A1B}" type="datetimeFigureOut">
              <a:rPr lang="it-IT" smtClean="0"/>
              <a:t>28/05/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4B168-B862-6944-BF16-539E26AF596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262910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C2ACE-12A3-5944-BFEF-67A4AB473A1B}" type="datetimeFigureOut">
              <a:rPr lang="it-IT" smtClean="0"/>
              <a:t>28/05/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4B168-B862-6944-BF16-539E26AF596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004275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C2ACE-12A3-5944-BFEF-67A4AB473A1B}" type="datetimeFigureOut">
              <a:rPr lang="it-IT" smtClean="0"/>
              <a:t>28/05/19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4B168-B862-6944-BF16-539E26AF596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548816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C2ACE-12A3-5944-BFEF-67A4AB473A1B}" type="datetimeFigureOut">
              <a:rPr lang="it-IT" smtClean="0"/>
              <a:t>28/05/19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4B168-B862-6944-BF16-539E26AF596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060331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C2ACE-12A3-5944-BFEF-67A4AB473A1B}" type="datetimeFigureOut">
              <a:rPr lang="it-IT" smtClean="0"/>
              <a:t>28/05/19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4B168-B862-6944-BF16-539E26AF596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033781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C2ACE-12A3-5944-BFEF-67A4AB473A1B}" type="datetimeFigureOut">
              <a:rPr lang="it-IT" smtClean="0"/>
              <a:t>28/05/19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4B168-B862-6944-BF16-539E26AF596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622256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C2ACE-12A3-5944-BFEF-67A4AB473A1B}" type="datetimeFigureOut">
              <a:rPr lang="it-IT" smtClean="0"/>
              <a:t>28/05/19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4B168-B862-6944-BF16-539E26AF596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228129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C2ACE-12A3-5944-BFEF-67A4AB473A1B}" type="datetimeFigureOut">
              <a:rPr lang="it-IT" smtClean="0"/>
              <a:t>28/05/19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4B168-B862-6944-BF16-539E26AF596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15853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DC2ACE-12A3-5944-BFEF-67A4AB473A1B}" type="datetimeFigureOut">
              <a:rPr lang="it-IT" smtClean="0"/>
              <a:t>28/05/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94B168-B862-6944-BF16-539E26AF596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254790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uppo 11">
            <a:extLst>
              <a:ext uri="{FF2B5EF4-FFF2-40B4-BE49-F238E27FC236}">
                <a16:creationId xmlns:a16="http://schemas.microsoft.com/office/drawing/2014/main" id="{A7DD5CC7-CD9A-BC49-B55B-04CE3E760202}"/>
              </a:ext>
            </a:extLst>
          </p:cNvPr>
          <p:cNvGrpSpPr/>
          <p:nvPr/>
        </p:nvGrpSpPr>
        <p:grpSpPr>
          <a:xfrm>
            <a:off x="1196501" y="190896"/>
            <a:ext cx="7966955" cy="6225461"/>
            <a:chOff x="1196501" y="190896"/>
            <a:chExt cx="7966955" cy="6225461"/>
          </a:xfrm>
        </p:grpSpPr>
        <p:sp>
          <p:nvSpPr>
            <p:cNvPr id="5" name="Rettangolo 4">
              <a:extLst>
                <a:ext uri="{FF2B5EF4-FFF2-40B4-BE49-F238E27FC236}">
                  <a16:creationId xmlns:a16="http://schemas.microsoft.com/office/drawing/2014/main" id="{C957B818-968C-344A-A982-C8278BABD912}"/>
                </a:ext>
              </a:extLst>
            </p:cNvPr>
            <p:cNvSpPr/>
            <p:nvPr/>
          </p:nvSpPr>
          <p:spPr>
            <a:xfrm>
              <a:off x="6887832" y="6108580"/>
              <a:ext cx="2275624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400" b="1" dirty="0">
                  <a:latin typeface="Times New Roman" panose="02020603050405020304" pitchFamily="18" charset="0"/>
                  <a:ea typeface="Calibri" panose="020F0502020204030204" pitchFamily="34" charset="0"/>
                </a:rPr>
                <a:t>Additional file 5: Figure S3 </a:t>
              </a:r>
              <a:endParaRPr lang="it-IT" sz="1400" dirty="0"/>
            </a:p>
          </p:txBody>
        </p:sp>
        <p:sp>
          <p:nvSpPr>
            <p:cNvPr id="2" name="CasellaDiTesto 1">
              <a:extLst>
                <a:ext uri="{FF2B5EF4-FFF2-40B4-BE49-F238E27FC236}">
                  <a16:creationId xmlns:a16="http://schemas.microsoft.com/office/drawing/2014/main" id="{81E54480-D941-7B4B-8EA8-12A554A2A51F}"/>
                </a:ext>
              </a:extLst>
            </p:cNvPr>
            <p:cNvSpPr txBox="1"/>
            <p:nvPr/>
          </p:nvSpPr>
          <p:spPr>
            <a:xfrm>
              <a:off x="3551654" y="190896"/>
              <a:ext cx="261642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masl </a:t>
              </a:r>
              <a:r>
                <a:rPr lang="it-IT" sz="16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etabolic</a:t>
              </a:r>
              <a:r>
                <a:rPr lang="it-IT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sz="16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athways</a:t>
              </a:r>
              <a:endParaRPr lang="it-IT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4" name="Immagine 3">
              <a:extLst>
                <a:ext uri="{FF2B5EF4-FFF2-40B4-BE49-F238E27FC236}">
                  <a16:creationId xmlns:a16="http://schemas.microsoft.com/office/drawing/2014/main" id="{0121CEF4-F784-1E44-AB30-5846DBB9DE5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>
                      <a14:imgEffect>
                        <a14:brightnessContrast contrast="-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196501" y="834617"/>
              <a:ext cx="7840493" cy="5116566"/>
            </a:xfrm>
            <a:prstGeom prst="rect">
              <a:avLst/>
            </a:prstGeom>
          </p:spPr>
        </p:pic>
        <p:sp>
          <p:nvSpPr>
            <p:cNvPr id="3" name="CasellaDiTesto 2">
              <a:extLst>
                <a:ext uri="{FF2B5EF4-FFF2-40B4-BE49-F238E27FC236}">
                  <a16:creationId xmlns:a16="http://schemas.microsoft.com/office/drawing/2014/main" id="{EEF1493F-5101-0F43-9614-C7A095D67CB1}"/>
                </a:ext>
              </a:extLst>
            </p:cNvPr>
            <p:cNvSpPr txBox="1"/>
            <p:nvPr/>
          </p:nvSpPr>
          <p:spPr>
            <a:xfrm>
              <a:off x="2978425" y="2955235"/>
              <a:ext cx="573229" cy="153888"/>
            </a:xfrm>
            <a:prstGeom prst="rect">
              <a:avLst/>
            </a:prstGeom>
            <a:solidFill>
              <a:srgbClr val="38A761"/>
            </a:solidFill>
          </p:spPr>
          <p:txBody>
            <a:bodyPr wrap="square" rtlCol="0">
              <a:spAutoFit/>
            </a:bodyPr>
            <a:lstStyle/>
            <a:p>
              <a:r>
                <a:rPr lang="it-IT" sz="400" b="1" dirty="0" err="1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Lipid</a:t>
              </a:r>
              <a:r>
                <a:rPr lang="it-IT" sz="4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sz="400" b="1" dirty="0" err="1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etabolism</a:t>
              </a:r>
              <a:endParaRPr lang="it-IT" sz="4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CasellaDiTesto 5">
              <a:extLst>
                <a:ext uri="{FF2B5EF4-FFF2-40B4-BE49-F238E27FC236}">
                  <a16:creationId xmlns:a16="http://schemas.microsoft.com/office/drawing/2014/main" id="{4DC72631-5EC0-2D4F-8D90-983881A8EEED}"/>
                </a:ext>
              </a:extLst>
            </p:cNvPr>
            <p:cNvSpPr txBox="1"/>
            <p:nvPr/>
          </p:nvSpPr>
          <p:spPr>
            <a:xfrm>
              <a:off x="3949147" y="2849217"/>
              <a:ext cx="493644" cy="215444"/>
            </a:xfrm>
            <a:prstGeom prst="rect">
              <a:avLst/>
            </a:prstGeom>
            <a:solidFill>
              <a:srgbClr val="2647D2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400" b="1" dirty="0" err="1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arbohydrate</a:t>
              </a:r>
              <a:r>
                <a:rPr lang="it-IT" sz="4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sz="400" b="1" dirty="0" err="1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etabolism</a:t>
              </a:r>
              <a:endParaRPr lang="it-IT" sz="4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CasellaDiTesto 6">
              <a:extLst>
                <a:ext uri="{FF2B5EF4-FFF2-40B4-BE49-F238E27FC236}">
                  <a16:creationId xmlns:a16="http://schemas.microsoft.com/office/drawing/2014/main" id="{3130DFEA-FFB5-8E43-9003-EE50CEAD4718}"/>
                </a:ext>
              </a:extLst>
            </p:cNvPr>
            <p:cNvSpPr txBox="1"/>
            <p:nvPr/>
          </p:nvSpPr>
          <p:spPr>
            <a:xfrm>
              <a:off x="4934226" y="3202885"/>
              <a:ext cx="441049" cy="215444"/>
            </a:xfrm>
            <a:prstGeom prst="rect">
              <a:avLst/>
            </a:prstGeom>
            <a:solidFill>
              <a:srgbClr val="B045AD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4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nergy </a:t>
              </a:r>
              <a:r>
                <a:rPr lang="it-IT" sz="400" b="1" dirty="0" err="1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etabolism</a:t>
              </a:r>
              <a:endParaRPr lang="it-IT" sz="4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CasellaDiTesto 7">
              <a:extLst>
                <a:ext uri="{FF2B5EF4-FFF2-40B4-BE49-F238E27FC236}">
                  <a16:creationId xmlns:a16="http://schemas.microsoft.com/office/drawing/2014/main" id="{F567AA43-A98D-ED4C-90CC-B03C1DFFD4B7}"/>
                </a:ext>
              </a:extLst>
            </p:cNvPr>
            <p:cNvSpPr txBox="1"/>
            <p:nvPr/>
          </p:nvSpPr>
          <p:spPr>
            <a:xfrm>
              <a:off x="4859865" y="2893679"/>
              <a:ext cx="446651" cy="215444"/>
            </a:xfrm>
            <a:prstGeom prst="rect">
              <a:avLst/>
            </a:prstGeom>
            <a:solidFill>
              <a:srgbClr val="FFB030"/>
            </a:solidFill>
          </p:spPr>
          <p:txBody>
            <a:bodyPr wrap="square" rtlCol="0">
              <a:spAutoFit/>
            </a:bodyPr>
            <a:lstStyle/>
            <a:p>
              <a:r>
                <a:rPr lang="it-IT" sz="4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mino Acid </a:t>
              </a:r>
              <a:r>
                <a:rPr lang="it-IT" sz="400" b="1" dirty="0" err="1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etabolism</a:t>
              </a:r>
              <a:endParaRPr lang="it-IT" sz="4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CasellaDiTesto 8">
              <a:extLst>
                <a:ext uri="{FF2B5EF4-FFF2-40B4-BE49-F238E27FC236}">
                  <a16:creationId xmlns:a16="http://schemas.microsoft.com/office/drawing/2014/main" id="{46C99C1C-E251-A740-A12A-93A8F81F7033}"/>
                </a:ext>
              </a:extLst>
            </p:cNvPr>
            <p:cNvSpPr txBox="1"/>
            <p:nvPr/>
          </p:nvSpPr>
          <p:spPr>
            <a:xfrm>
              <a:off x="7132300" y="850084"/>
              <a:ext cx="465475" cy="215444"/>
            </a:xfrm>
            <a:prstGeom prst="rect">
              <a:avLst/>
            </a:prstGeom>
            <a:solidFill>
              <a:srgbClr val="FF0000"/>
            </a:solidFill>
          </p:spPr>
          <p:txBody>
            <a:bodyPr wrap="square" rtlCol="0">
              <a:spAutoFit/>
            </a:bodyPr>
            <a:lstStyle/>
            <a:p>
              <a:r>
                <a:rPr lang="it-IT" sz="4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ucleotide  </a:t>
              </a:r>
              <a:r>
                <a:rPr lang="it-IT" sz="400" b="1" dirty="0" err="1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etabolism</a:t>
              </a:r>
              <a:endParaRPr lang="it-IT" sz="4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CasellaDiTesto 9">
              <a:extLst>
                <a:ext uri="{FF2B5EF4-FFF2-40B4-BE49-F238E27FC236}">
                  <a16:creationId xmlns:a16="http://schemas.microsoft.com/office/drawing/2014/main" id="{91D53810-5285-EF48-8CFC-6FCC9B556A50}"/>
                </a:ext>
              </a:extLst>
            </p:cNvPr>
            <p:cNvSpPr txBox="1"/>
            <p:nvPr/>
          </p:nvSpPr>
          <p:spPr>
            <a:xfrm>
              <a:off x="8372352" y="3109123"/>
              <a:ext cx="664642" cy="215444"/>
            </a:xfrm>
            <a:prstGeom prst="rect">
              <a:avLst/>
            </a:prstGeom>
            <a:solidFill>
              <a:srgbClr val="D64291"/>
            </a:solidFill>
          </p:spPr>
          <p:txBody>
            <a:bodyPr wrap="square" rtlCol="0">
              <a:spAutoFit/>
            </a:bodyPr>
            <a:lstStyle/>
            <a:p>
              <a:r>
                <a:rPr lang="it-IT" sz="400" b="1" dirty="0" err="1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iosynthesis</a:t>
              </a:r>
              <a:r>
                <a:rPr lang="it-IT" sz="4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of </a:t>
              </a:r>
              <a:r>
                <a:rPr lang="it-IT" sz="400" b="1" dirty="0" err="1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ther</a:t>
              </a:r>
              <a:r>
                <a:rPr lang="it-IT" sz="4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sz="400" b="1" dirty="0" err="1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econdary</a:t>
              </a:r>
              <a:r>
                <a:rPr lang="it-IT" sz="4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sz="400" b="1" dirty="0" err="1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etabolites</a:t>
              </a:r>
              <a:endParaRPr lang="it-IT" sz="4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CasellaDiTesto 10">
              <a:extLst>
                <a:ext uri="{FF2B5EF4-FFF2-40B4-BE49-F238E27FC236}">
                  <a16:creationId xmlns:a16="http://schemas.microsoft.com/office/drawing/2014/main" id="{737822A9-6723-C949-82A0-4008CEF76A63}"/>
                </a:ext>
              </a:extLst>
            </p:cNvPr>
            <p:cNvSpPr txBox="1"/>
            <p:nvPr/>
          </p:nvSpPr>
          <p:spPr>
            <a:xfrm>
              <a:off x="5350735" y="5382114"/>
              <a:ext cx="599215" cy="215444"/>
            </a:xfrm>
            <a:prstGeom prst="rect">
              <a:avLst/>
            </a:prstGeom>
            <a:solidFill>
              <a:srgbClr val="FF9419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400" b="1" dirty="0" err="1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etabolism</a:t>
              </a:r>
              <a:r>
                <a:rPr lang="it-IT" sz="4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of </a:t>
              </a:r>
              <a:r>
                <a:rPr lang="it-IT" sz="400" b="1" dirty="0" err="1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ther</a:t>
              </a:r>
              <a:r>
                <a:rPr lang="it-IT" sz="4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Amino Acid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267971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3</TotalTime>
  <Words>30</Words>
  <Application>Microsoft Macintosh PowerPoint</Application>
  <PresentationFormat>A4 (21x29,7 cm)</PresentationFormat>
  <Paragraphs>9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Utente di Microsoft Office</dc:creator>
  <cp:lastModifiedBy>Utente di Microsoft Office</cp:lastModifiedBy>
  <cp:revision>10</cp:revision>
  <dcterms:created xsi:type="dcterms:W3CDTF">2018-10-03T14:57:38Z</dcterms:created>
  <dcterms:modified xsi:type="dcterms:W3CDTF">2019-05-28T10:11:42Z</dcterms:modified>
</cp:coreProperties>
</file>